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8" r:id="rId2"/>
  </p:sldIdLst>
  <p:sldSz cx="9906000" cy="6858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72C4"/>
    <a:srgbClr val="00B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358"/>
    <p:restoredTop sz="94653"/>
  </p:normalViewPr>
  <p:slideViewPr>
    <p:cSldViewPr snapToGrid="0" snapToObjects="1">
      <p:cViewPr varScale="1">
        <p:scale>
          <a:sx n="70" d="100"/>
          <a:sy n="70" d="100"/>
        </p:scale>
        <p:origin x="1104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2807527-07BA-9341-A341-0ED54C0FF123}" type="datetimeFigureOut">
              <a:rPr lang="fr-FR" smtClean="0"/>
              <a:t>26/08/2022</a:t>
            </a:fld>
            <a:endParaRPr lang="fr-FR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822F6A-999A-5A4D-B49F-97991B822D2C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86375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FR" dirty="0"/>
              <a:t>Version 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F822F6A-999A-5A4D-B49F-97991B822D2C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2501999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431AE-5FDB-E14A-BAF7-26DC73F6E02F}" type="datetimeFigureOut">
              <a:rPr lang="fr-FR" smtClean="0"/>
              <a:t>26/08/2022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A46F1-FF49-5D4F-A6BA-CDE113A9C24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634404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431AE-5FDB-E14A-BAF7-26DC73F6E02F}" type="datetimeFigureOut">
              <a:rPr lang="fr-FR" smtClean="0"/>
              <a:t>26/08/2022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A46F1-FF49-5D4F-A6BA-CDE113A9C24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7771303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431AE-5FDB-E14A-BAF7-26DC73F6E02F}" type="datetimeFigureOut">
              <a:rPr lang="fr-FR" smtClean="0"/>
              <a:t>26/08/2022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A46F1-FF49-5D4F-A6BA-CDE113A9C24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13937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431AE-5FDB-E14A-BAF7-26DC73F6E02F}" type="datetimeFigureOut">
              <a:rPr lang="fr-FR" smtClean="0"/>
              <a:t>26/08/2022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A46F1-FF49-5D4F-A6BA-CDE113A9C24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6667716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431AE-5FDB-E14A-BAF7-26DC73F6E02F}" type="datetimeFigureOut">
              <a:rPr lang="fr-FR" smtClean="0"/>
              <a:t>26/08/2022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A46F1-FF49-5D4F-A6BA-CDE113A9C24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6833142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431AE-5FDB-E14A-BAF7-26DC73F6E02F}" type="datetimeFigureOut">
              <a:rPr lang="fr-FR" smtClean="0"/>
              <a:t>26/08/2022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A46F1-FF49-5D4F-A6BA-CDE113A9C24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4922920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431AE-5FDB-E14A-BAF7-26DC73F6E02F}" type="datetimeFigureOut">
              <a:rPr lang="fr-FR" smtClean="0"/>
              <a:t>26/08/2022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A46F1-FF49-5D4F-A6BA-CDE113A9C24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9051116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431AE-5FDB-E14A-BAF7-26DC73F6E02F}" type="datetimeFigureOut">
              <a:rPr lang="fr-FR" smtClean="0"/>
              <a:t>26/08/2022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A46F1-FF49-5D4F-A6BA-CDE113A9C24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546153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431AE-5FDB-E14A-BAF7-26DC73F6E02F}" type="datetimeFigureOut">
              <a:rPr lang="fr-FR" smtClean="0"/>
              <a:t>26/08/2022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A46F1-FF49-5D4F-A6BA-CDE113A9C24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997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431AE-5FDB-E14A-BAF7-26DC73F6E02F}" type="datetimeFigureOut">
              <a:rPr lang="fr-FR" smtClean="0"/>
              <a:t>26/08/2022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A46F1-FF49-5D4F-A6BA-CDE113A9C24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2164938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431AE-5FDB-E14A-BAF7-26DC73F6E02F}" type="datetimeFigureOut">
              <a:rPr lang="fr-FR" smtClean="0"/>
              <a:t>26/08/2022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3A46F1-FF49-5D4F-A6BA-CDE113A9C24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1895882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7431AE-5FDB-E14A-BAF7-26DC73F6E02F}" type="datetimeFigureOut">
              <a:rPr lang="fr-FR" smtClean="0"/>
              <a:t>26/08/2022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3A46F1-FF49-5D4F-A6BA-CDE113A9C245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2964913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Group 31">
            <a:extLst>
              <a:ext uri="{FF2B5EF4-FFF2-40B4-BE49-F238E27FC236}">
                <a16:creationId xmlns:a16="http://schemas.microsoft.com/office/drawing/2014/main" id="{25A1BD04-F1C0-E948-8999-F1AE803E1DEE}"/>
              </a:ext>
            </a:extLst>
          </p:cNvPr>
          <p:cNvGrpSpPr/>
          <p:nvPr/>
        </p:nvGrpSpPr>
        <p:grpSpPr>
          <a:xfrm>
            <a:off x="538918" y="151743"/>
            <a:ext cx="8839004" cy="5213783"/>
            <a:chOff x="801384" y="651276"/>
            <a:chExt cx="8839004" cy="5213783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8A99A8C8-6B90-5140-8B41-8259C546961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9061" t="9497" b="14478"/>
            <a:stretch/>
          </p:blipFill>
          <p:spPr>
            <a:xfrm>
              <a:off x="801384" y="651276"/>
              <a:ext cx="7945274" cy="5213783"/>
            </a:xfrm>
            <a:prstGeom prst="rect">
              <a:avLst/>
            </a:prstGeom>
          </p:spPr>
        </p:pic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E6BA26CB-6731-EE4B-8718-BD0C9730AD13}"/>
                </a:ext>
              </a:extLst>
            </p:cNvPr>
            <p:cNvSpPr txBox="1"/>
            <p:nvPr/>
          </p:nvSpPr>
          <p:spPr>
            <a:xfrm>
              <a:off x="2140408" y="1227113"/>
              <a:ext cx="51648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400" dirty="0"/>
                <a:t>A*</a:t>
              </a:r>
              <a:endParaRPr lang="fr-FR" sz="2400" baseline="30000" dirty="0"/>
            </a:p>
          </p:txBody>
        </p: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96DD4B4B-E691-0546-99CA-23A58330E179}"/>
                </a:ext>
              </a:extLst>
            </p:cNvPr>
            <p:cNvGrpSpPr/>
            <p:nvPr/>
          </p:nvGrpSpPr>
          <p:grpSpPr>
            <a:xfrm>
              <a:off x="8063022" y="802054"/>
              <a:ext cx="1298753" cy="4893187"/>
              <a:chOff x="8176235" y="802054"/>
              <a:chExt cx="1298753" cy="4893187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A3C3C04C-23A0-F040-A045-F5CB9B7C274D}"/>
                  </a:ext>
                </a:extLst>
              </p:cNvPr>
              <p:cNvSpPr txBox="1"/>
              <p:nvPr/>
            </p:nvSpPr>
            <p:spPr>
              <a:xfrm>
                <a:off x="8176235" y="2500354"/>
                <a:ext cx="4695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Iran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BA90FA1F-C8BB-8340-BD69-F3DE7FDB0BFE}"/>
                  </a:ext>
                </a:extLst>
              </p:cNvPr>
              <p:cNvSpPr txBox="1"/>
              <p:nvPr/>
            </p:nvSpPr>
            <p:spPr>
              <a:xfrm>
                <a:off x="8176235" y="2330524"/>
                <a:ext cx="4695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Iran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B0F6E3D2-297E-E749-B48F-42304C841DBF}"/>
                  </a:ext>
                </a:extLst>
              </p:cNvPr>
              <p:cNvSpPr txBox="1"/>
              <p:nvPr/>
            </p:nvSpPr>
            <p:spPr>
              <a:xfrm>
                <a:off x="8176235" y="2160694"/>
                <a:ext cx="4695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Iran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96E7C792-6F57-844C-BB27-68541EF3303B}"/>
                  </a:ext>
                </a:extLst>
              </p:cNvPr>
              <p:cNvSpPr txBox="1"/>
              <p:nvPr/>
            </p:nvSpPr>
            <p:spPr>
              <a:xfrm>
                <a:off x="8176235" y="1481374"/>
                <a:ext cx="62709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Oman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21EB9057-68D3-994D-A858-7F23A6A64080}"/>
                  </a:ext>
                </a:extLst>
              </p:cNvPr>
              <p:cNvSpPr txBox="1"/>
              <p:nvPr/>
            </p:nvSpPr>
            <p:spPr>
              <a:xfrm>
                <a:off x="8176235" y="802054"/>
                <a:ext cx="54694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India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EC688A61-A69E-7F48-8FCE-F7407FDFC318}"/>
                  </a:ext>
                </a:extLst>
              </p:cNvPr>
              <p:cNvSpPr txBox="1"/>
              <p:nvPr/>
            </p:nvSpPr>
            <p:spPr>
              <a:xfrm>
                <a:off x="8176235" y="4538314"/>
                <a:ext cx="81304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Thailand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1D662C91-0AAE-7C46-B08A-B3636400096F}"/>
                  </a:ext>
                </a:extLst>
              </p:cNvPr>
              <p:cNvSpPr txBox="1"/>
              <p:nvPr/>
            </p:nvSpPr>
            <p:spPr>
              <a:xfrm>
                <a:off x="8176235" y="3349504"/>
                <a:ext cx="109632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Saudi Arabia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47CB2D02-0A8C-104B-8BF3-BF43E51ADF45}"/>
                  </a:ext>
                </a:extLst>
              </p:cNvPr>
              <p:cNvSpPr txBox="1"/>
              <p:nvPr/>
            </p:nvSpPr>
            <p:spPr>
              <a:xfrm>
                <a:off x="8176235" y="3009844"/>
                <a:ext cx="109632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Saudi Arabia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7AEF8182-8D7F-E346-974C-88E70BF74C03}"/>
                  </a:ext>
                </a:extLst>
              </p:cNvPr>
              <p:cNvSpPr txBox="1"/>
              <p:nvPr/>
            </p:nvSpPr>
            <p:spPr>
              <a:xfrm>
                <a:off x="8176235" y="3689164"/>
                <a:ext cx="74360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Ethopia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8852ED16-5410-6942-95F6-CD5055E90D5C}"/>
                  </a:ext>
                </a:extLst>
              </p:cNvPr>
              <p:cNvSpPr txBox="1"/>
              <p:nvPr/>
            </p:nvSpPr>
            <p:spPr>
              <a:xfrm>
                <a:off x="8176235" y="1990864"/>
                <a:ext cx="129875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Southwest Asia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B4B5B613-88B4-0D4A-8C95-A07EBAC80572}"/>
                  </a:ext>
                </a:extLst>
              </p:cNvPr>
              <p:cNvSpPr txBox="1"/>
              <p:nvPr/>
            </p:nvSpPr>
            <p:spPr>
              <a:xfrm>
                <a:off x="8176235" y="4198654"/>
                <a:ext cx="81304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Thailand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4C7625A0-BD03-4D40-AA9A-5023ACF86F92}"/>
                  </a:ext>
                </a:extLst>
              </p:cNvPr>
              <p:cNvSpPr txBox="1"/>
              <p:nvPr/>
            </p:nvSpPr>
            <p:spPr>
              <a:xfrm>
                <a:off x="8176235" y="3858994"/>
                <a:ext cx="4695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Iran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33D99B8D-337B-574A-8E23-2F05AC2FF2BD}"/>
                  </a:ext>
                </a:extLst>
              </p:cNvPr>
              <p:cNvSpPr txBox="1"/>
              <p:nvPr/>
            </p:nvSpPr>
            <p:spPr>
              <a:xfrm>
                <a:off x="8176235" y="4028824"/>
                <a:ext cx="4695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Iran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2AF70892-73BE-6744-9BD8-DA002306FC58}"/>
                  </a:ext>
                </a:extLst>
              </p:cNvPr>
              <p:cNvSpPr txBox="1"/>
              <p:nvPr/>
            </p:nvSpPr>
            <p:spPr>
              <a:xfrm>
                <a:off x="8176235" y="1651204"/>
                <a:ext cx="109632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Saudi Arabia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845F68D2-47F2-5744-BF95-626BC6D3425C}"/>
                  </a:ext>
                </a:extLst>
              </p:cNvPr>
              <p:cNvSpPr txBox="1"/>
              <p:nvPr/>
            </p:nvSpPr>
            <p:spPr>
              <a:xfrm>
                <a:off x="8176235" y="1311544"/>
                <a:ext cx="62709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Oman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46A5711B-7C91-D548-A2AD-6D04E8CCEBA1}"/>
                  </a:ext>
                </a:extLst>
              </p:cNvPr>
              <p:cNvSpPr txBox="1"/>
              <p:nvPr/>
            </p:nvSpPr>
            <p:spPr>
              <a:xfrm>
                <a:off x="8176235" y="1141714"/>
                <a:ext cx="79220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Pakistan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F6727D29-F0DC-5A4D-A7CB-20AB024EB61B}"/>
                  </a:ext>
                </a:extLst>
              </p:cNvPr>
              <p:cNvSpPr txBox="1"/>
              <p:nvPr/>
            </p:nvSpPr>
            <p:spPr>
              <a:xfrm>
                <a:off x="8176235" y="971884"/>
                <a:ext cx="54694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India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3F7DD511-63BB-5B44-9E6E-58BD5428B521}"/>
                  </a:ext>
                </a:extLst>
              </p:cNvPr>
              <p:cNvSpPr txBox="1"/>
              <p:nvPr/>
            </p:nvSpPr>
            <p:spPr>
              <a:xfrm>
                <a:off x="8176235" y="1821034"/>
                <a:ext cx="4695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Iran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CE050BFF-E215-3A44-A203-8A11ECA9CAB5}"/>
                  </a:ext>
                </a:extLst>
              </p:cNvPr>
              <p:cNvSpPr txBox="1"/>
              <p:nvPr/>
            </p:nvSpPr>
            <p:spPr>
              <a:xfrm>
                <a:off x="8176235" y="3519334"/>
                <a:ext cx="74360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Ethopia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05A239D1-1CB3-3E49-8334-1A65CC61CB52}"/>
                  </a:ext>
                </a:extLst>
              </p:cNvPr>
              <p:cNvSpPr txBox="1"/>
              <p:nvPr/>
            </p:nvSpPr>
            <p:spPr>
              <a:xfrm>
                <a:off x="8176235" y="3179674"/>
                <a:ext cx="109632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Saudi Arabia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7F361A98-1E3B-4444-97DC-F699D734331D}"/>
                  </a:ext>
                </a:extLst>
              </p:cNvPr>
              <p:cNvSpPr txBox="1"/>
              <p:nvPr/>
            </p:nvSpPr>
            <p:spPr>
              <a:xfrm>
                <a:off x="8176235" y="4708144"/>
                <a:ext cx="90281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Thailand*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1A5E78D5-8280-1A4D-BA0F-C20043F64F9B}"/>
                  </a:ext>
                </a:extLst>
              </p:cNvPr>
              <p:cNvSpPr txBox="1"/>
              <p:nvPr/>
            </p:nvSpPr>
            <p:spPr>
              <a:xfrm>
                <a:off x="8176235" y="4368484"/>
                <a:ext cx="92204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Cambodia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B80374FA-4AF5-D34B-908F-1851ACF365CC}"/>
                  </a:ext>
                </a:extLst>
              </p:cNvPr>
              <p:cNvSpPr txBox="1"/>
              <p:nvPr/>
            </p:nvSpPr>
            <p:spPr>
              <a:xfrm>
                <a:off x="8176235" y="4877974"/>
                <a:ext cx="81304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Thailand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FAAC424F-D9E3-9944-A361-4B2979073A14}"/>
                  </a:ext>
                </a:extLst>
              </p:cNvPr>
              <p:cNvSpPr txBox="1"/>
              <p:nvPr/>
            </p:nvSpPr>
            <p:spPr>
              <a:xfrm>
                <a:off x="8176235" y="5387464"/>
                <a:ext cx="63671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India*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91863D7A-B187-FC4F-84CF-338483B0D99D}"/>
                  </a:ext>
                </a:extLst>
              </p:cNvPr>
              <p:cNvSpPr txBox="1"/>
              <p:nvPr/>
            </p:nvSpPr>
            <p:spPr>
              <a:xfrm>
                <a:off x="8176235" y="2670184"/>
                <a:ext cx="109632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Saudi Arabia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5FF44E0A-F68C-9549-B170-863073CB119B}"/>
                  </a:ext>
                </a:extLst>
              </p:cNvPr>
              <p:cNvSpPr txBox="1"/>
              <p:nvPr/>
            </p:nvSpPr>
            <p:spPr>
              <a:xfrm>
                <a:off x="8176235" y="5217634"/>
                <a:ext cx="81304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Thailand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C49380AE-4D8C-B44C-B006-DB83F062D4A4}"/>
                  </a:ext>
                </a:extLst>
              </p:cNvPr>
              <p:cNvSpPr txBox="1"/>
              <p:nvPr/>
            </p:nvSpPr>
            <p:spPr>
              <a:xfrm>
                <a:off x="8176235" y="5047804"/>
                <a:ext cx="99969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Singapore*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3C46EE8B-B0B3-A74A-9832-94FE74D49C37}"/>
                  </a:ext>
                </a:extLst>
              </p:cNvPr>
              <p:cNvSpPr txBox="1"/>
              <p:nvPr/>
            </p:nvSpPr>
            <p:spPr>
              <a:xfrm>
                <a:off x="8176235" y="2840014"/>
                <a:ext cx="109632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Saudi Arabia</a:t>
                </a:r>
              </a:p>
            </p:txBody>
          </p:sp>
        </p:grpSp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6FE8AC2C-067E-5C44-99A4-7C5D5F3F588B}"/>
                </a:ext>
              </a:extLst>
            </p:cNvPr>
            <p:cNvGrpSpPr/>
            <p:nvPr/>
          </p:nvGrpSpPr>
          <p:grpSpPr>
            <a:xfrm>
              <a:off x="7440365" y="802054"/>
              <a:ext cx="367408" cy="5063005"/>
              <a:chOff x="9177757" y="802054"/>
              <a:chExt cx="367408" cy="5063005"/>
            </a:xfrm>
          </p:grpSpPr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E3CF331A-94DD-8244-91C6-6623920BD746}"/>
                  </a:ext>
                </a:extLst>
              </p:cNvPr>
              <p:cNvSpPr txBox="1"/>
              <p:nvPr/>
            </p:nvSpPr>
            <p:spPr>
              <a:xfrm>
                <a:off x="9177757" y="250035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18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151B18D9-0332-224D-AFDF-31501FF6C91E}"/>
                  </a:ext>
                </a:extLst>
              </p:cNvPr>
              <p:cNvSpPr txBox="1"/>
              <p:nvPr/>
            </p:nvSpPr>
            <p:spPr>
              <a:xfrm>
                <a:off x="9177757" y="233052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18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4761646E-A350-B344-8B5F-721DFF5FC31F}"/>
                  </a:ext>
                </a:extLst>
              </p:cNvPr>
              <p:cNvSpPr txBox="1"/>
              <p:nvPr/>
            </p:nvSpPr>
            <p:spPr>
              <a:xfrm>
                <a:off x="9177757" y="216069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18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56AA1BF2-6030-EC42-BB2D-F889726C2695}"/>
                  </a:ext>
                </a:extLst>
              </p:cNvPr>
              <p:cNvSpPr txBox="1"/>
              <p:nvPr/>
            </p:nvSpPr>
            <p:spPr>
              <a:xfrm>
                <a:off x="9177757" y="148137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10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82B20E12-9EC2-9A44-BF4E-0CE70CADB81E}"/>
                  </a:ext>
                </a:extLst>
              </p:cNvPr>
              <p:cNvSpPr txBox="1"/>
              <p:nvPr/>
            </p:nvSpPr>
            <p:spPr>
              <a:xfrm>
                <a:off x="9177757" y="80205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10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E732E8B7-E3DE-4043-B54F-18E725F542EF}"/>
                  </a:ext>
                </a:extLst>
              </p:cNvPr>
              <p:cNvSpPr txBox="1"/>
              <p:nvPr/>
            </p:nvSpPr>
            <p:spPr>
              <a:xfrm>
                <a:off x="9177757" y="453831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16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3266E7CF-4897-A94A-84BE-2D6DD38FC813}"/>
                  </a:ext>
                </a:extLst>
              </p:cNvPr>
              <p:cNvSpPr txBox="1"/>
              <p:nvPr/>
            </p:nvSpPr>
            <p:spPr>
              <a:xfrm>
                <a:off x="9177757" y="334950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09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DBCE89D2-3C85-C444-BC98-1841A16998E3}"/>
                  </a:ext>
                </a:extLst>
              </p:cNvPr>
              <p:cNvSpPr txBox="1"/>
              <p:nvPr/>
            </p:nvSpPr>
            <p:spPr>
              <a:xfrm>
                <a:off x="9177757" y="300984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09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11341E36-69E1-8947-88F1-E96A22ADDA7E}"/>
                  </a:ext>
                </a:extLst>
              </p:cNvPr>
              <p:cNvSpPr txBox="1"/>
              <p:nvPr/>
            </p:nvSpPr>
            <p:spPr>
              <a:xfrm>
                <a:off x="9177757" y="368916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12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E3BBE288-92C3-B14C-BB1F-E7DD4B3F7556}"/>
                  </a:ext>
                </a:extLst>
              </p:cNvPr>
              <p:cNvSpPr txBox="1"/>
              <p:nvPr/>
            </p:nvSpPr>
            <p:spPr>
              <a:xfrm>
                <a:off x="9177757" y="199086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18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48A55C01-FCE9-B348-BFFF-52040168BB24}"/>
                  </a:ext>
                </a:extLst>
              </p:cNvPr>
              <p:cNvSpPr txBox="1"/>
              <p:nvPr/>
            </p:nvSpPr>
            <p:spPr>
              <a:xfrm>
                <a:off x="9177757" y="5557282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14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2B8AD8CC-AE6D-0A4A-B4F8-9AA0385CBA5B}"/>
                  </a:ext>
                </a:extLst>
              </p:cNvPr>
              <p:cNvSpPr txBox="1"/>
              <p:nvPr/>
            </p:nvSpPr>
            <p:spPr>
              <a:xfrm>
                <a:off x="9177757" y="419865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16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FAEF373D-190A-D042-8450-607B05BE787D}"/>
                  </a:ext>
                </a:extLst>
              </p:cNvPr>
              <p:cNvSpPr txBox="1"/>
              <p:nvPr/>
            </p:nvSpPr>
            <p:spPr>
              <a:xfrm>
                <a:off x="9177757" y="385899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45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FCAFCB7D-1292-9843-AE87-E9E88CEA5C4D}"/>
                  </a:ext>
                </a:extLst>
              </p:cNvPr>
              <p:cNvSpPr txBox="1"/>
              <p:nvPr/>
            </p:nvSpPr>
            <p:spPr>
              <a:xfrm>
                <a:off x="9177757" y="402882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45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164A7816-29C0-CF46-BFC5-6CC0A729E7CE}"/>
                  </a:ext>
                </a:extLst>
              </p:cNvPr>
              <p:cNvSpPr txBox="1"/>
              <p:nvPr/>
            </p:nvSpPr>
            <p:spPr>
              <a:xfrm>
                <a:off x="9177757" y="165120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10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8C57DFE9-8C01-664C-8C23-7F1B3B155740}"/>
                  </a:ext>
                </a:extLst>
              </p:cNvPr>
              <p:cNvSpPr txBox="1"/>
              <p:nvPr/>
            </p:nvSpPr>
            <p:spPr>
              <a:xfrm>
                <a:off x="9177757" y="131154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10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FF3E909F-2E8C-A743-B23C-64716DE0F799}"/>
                  </a:ext>
                </a:extLst>
              </p:cNvPr>
              <p:cNvSpPr txBox="1"/>
              <p:nvPr/>
            </p:nvSpPr>
            <p:spPr>
              <a:xfrm>
                <a:off x="9177757" y="114171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11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9F905209-DCDF-C941-B329-513BCF9000D8}"/>
                  </a:ext>
                </a:extLst>
              </p:cNvPr>
              <p:cNvSpPr txBox="1"/>
              <p:nvPr/>
            </p:nvSpPr>
            <p:spPr>
              <a:xfrm>
                <a:off x="9177757" y="97188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24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2B1F81F2-7FDB-1943-8B57-A8E2F2A59E8B}"/>
                  </a:ext>
                </a:extLst>
              </p:cNvPr>
              <p:cNvSpPr txBox="1"/>
              <p:nvPr/>
            </p:nvSpPr>
            <p:spPr>
              <a:xfrm>
                <a:off x="9177757" y="182103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18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E461CB7D-7523-044C-9770-F15FD8D95352}"/>
                  </a:ext>
                </a:extLst>
              </p:cNvPr>
              <p:cNvSpPr txBox="1"/>
              <p:nvPr/>
            </p:nvSpPr>
            <p:spPr>
              <a:xfrm>
                <a:off x="9177757" y="351933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12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774E8B45-5F6F-E14A-9BA1-AF174656ADA5}"/>
                  </a:ext>
                </a:extLst>
              </p:cNvPr>
              <p:cNvSpPr txBox="1"/>
              <p:nvPr/>
            </p:nvSpPr>
            <p:spPr>
              <a:xfrm>
                <a:off x="9177757" y="317967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09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17B8B5E5-D37E-F64B-8849-3A31147A4442}"/>
                  </a:ext>
                </a:extLst>
              </p:cNvPr>
              <p:cNvSpPr txBox="1"/>
              <p:nvPr/>
            </p:nvSpPr>
            <p:spPr>
              <a:xfrm>
                <a:off x="9177757" y="470814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17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3C79A18B-30DD-E944-A975-42F1E9FDD373}"/>
                  </a:ext>
                </a:extLst>
              </p:cNvPr>
              <p:cNvSpPr txBox="1"/>
              <p:nvPr/>
            </p:nvSpPr>
            <p:spPr>
              <a:xfrm>
                <a:off x="9177757" y="436848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16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801E4C28-98E3-5A46-AFEA-A69018BB854E}"/>
                  </a:ext>
                </a:extLst>
              </p:cNvPr>
              <p:cNvSpPr txBox="1"/>
              <p:nvPr/>
            </p:nvSpPr>
            <p:spPr>
              <a:xfrm>
                <a:off x="9177757" y="487797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17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6FBFD633-B79B-A541-A667-B4F6F1C6F4D5}"/>
                  </a:ext>
                </a:extLst>
              </p:cNvPr>
              <p:cNvSpPr txBox="1"/>
              <p:nvPr/>
            </p:nvSpPr>
            <p:spPr>
              <a:xfrm>
                <a:off x="9177757" y="538746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10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9B31BF4E-9AC7-4D4C-98F7-915758CA31D0}"/>
                  </a:ext>
                </a:extLst>
              </p:cNvPr>
              <p:cNvSpPr txBox="1"/>
              <p:nvPr/>
            </p:nvSpPr>
            <p:spPr>
              <a:xfrm>
                <a:off x="9177757" y="267018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49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C483FBCE-4100-D148-A87A-B93F179C2BB7}"/>
                  </a:ext>
                </a:extLst>
              </p:cNvPr>
              <p:cNvSpPr txBox="1"/>
              <p:nvPr/>
            </p:nvSpPr>
            <p:spPr>
              <a:xfrm>
                <a:off x="9177757" y="521763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16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9FBE481D-3EEB-C54B-9003-2D3FA6EAA2EA}"/>
                  </a:ext>
                </a:extLst>
              </p:cNvPr>
              <p:cNvSpPr txBox="1"/>
              <p:nvPr/>
            </p:nvSpPr>
            <p:spPr>
              <a:xfrm>
                <a:off x="9177757" y="504780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16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A5749118-1707-AE45-9C31-B5DCD4BF8693}"/>
                  </a:ext>
                </a:extLst>
              </p:cNvPr>
              <p:cNvSpPr txBox="1"/>
              <p:nvPr/>
            </p:nvSpPr>
            <p:spPr>
              <a:xfrm>
                <a:off x="9177757" y="2840014"/>
                <a:ext cx="36740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/>
                  <a:t>09</a:t>
                </a:r>
              </a:p>
            </p:txBody>
          </p:sp>
        </p:grp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F9B9A4EE-5FFA-6643-B832-EE519F03C9A9}"/>
                </a:ext>
              </a:extLst>
            </p:cNvPr>
            <p:cNvSpPr/>
            <p:nvPr/>
          </p:nvSpPr>
          <p:spPr>
            <a:xfrm>
              <a:off x="6771830" y="651277"/>
              <a:ext cx="559966" cy="6990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67C95737-026A-DB48-B784-18DAF5D65DE3}"/>
                </a:ext>
              </a:extLst>
            </p:cNvPr>
            <p:cNvSpPr/>
            <p:nvPr/>
          </p:nvSpPr>
          <p:spPr>
            <a:xfrm>
              <a:off x="1863605" y="881890"/>
              <a:ext cx="7776783" cy="4752556"/>
            </a:xfrm>
            <a:prstGeom prst="rect">
              <a:avLst/>
            </a:prstGeom>
            <a:solidFill>
              <a:srgbClr val="FFFF00">
                <a:alpha val="20000"/>
              </a:srgb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B7A9AFB1-B900-224B-AC12-D412AFD3E5C7}"/>
                </a:ext>
              </a:extLst>
            </p:cNvPr>
            <p:cNvSpPr/>
            <p:nvPr/>
          </p:nvSpPr>
          <p:spPr>
            <a:xfrm>
              <a:off x="4184907" y="4268032"/>
              <a:ext cx="5432400" cy="1188000"/>
            </a:xfrm>
            <a:prstGeom prst="rect">
              <a:avLst/>
            </a:prstGeom>
            <a:solidFill>
              <a:srgbClr val="7030A0">
                <a:alpha val="25000"/>
              </a:srgbClr>
            </a:solidFill>
            <a:ln w="1905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4F74F888-EDEF-434F-A203-3B27A50868E1}"/>
                </a:ext>
              </a:extLst>
            </p:cNvPr>
            <p:cNvSpPr/>
            <p:nvPr/>
          </p:nvSpPr>
          <p:spPr>
            <a:xfrm>
              <a:off x="4206240" y="3582107"/>
              <a:ext cx="5432400" cy="687655"/>
            </a:xfrm>
            <a:prstGeom prst="rect">
              <a:avLst/>
            </a:prstGeom>
            <a:solidFill>
              <a:srgbClr val="FF0000">
                <a:alpha val="24000"/>
              </a:srgbClr>
            </a:solidFill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8893E6BB-B5AF-AA4C-AF2A-DE36A0F1B047}"/>
                </a:ext>
              </a:extLst>
            </p:cNvPr>
            <p:cNvSpPr/>
            <p:nvPr/>
          </p:nvSpPr>
          <p:spPr>
            <a:xfrm>
              <a:off x="4206240" y="1894168"/>
              <a:ext cx="5432400" cy="1683661"/>
            </a:xfrm>
            <a:prstGeom prst="rect">
              <a:avLst/>
            </a:prstGeom>
            <a:solidFill>
              <a:srgbClr val="00B050">
                <a:alpha val="25098"/>
              </a:srgbClr>
            </a:solidFill>
            <a:ln w="1905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0DC0A507-816C-8245-9853-6CF93F19DF6B}"/>
                </a:ext>
              </a:extLst>
            </p:cNvPr>
            <p:cNvSpPr/>
            <p:nvPr/>
          </p:nvSpPr>
          <p:spPr>
            <a:xfrm>
              <a:off x="4206240" y="881890"/>
              <a:ext cx="5432400" cy="1008000"/>
            </a:xfrm>
            <a:prstGeom prst="rect">
              <a:avLst/>
            </a:prstGeom>
            <a:solidFill>
              <a:srgbClr val="4472C4">
                <a:alpha val="25098"/>
              </a:srgbClr>
            </a:solidFill>
            <a:ln w="19050">
              <a:solidFill>
                <a:srgbClr val="4472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</p:grpSp>
      <p:sp>
        <p:nvSpPr>
          <p:cNvPr id="79" name="TextBox 78">
            <a:extLst>
              <a:ext uri="{FF2B5EF4-FFF2-40B4-BE49-F238E27FC236}">
                <a16:creationId xmlns:a16="http://schemas.microsoft.com/office/drawing/2014/main" id="{F1526932-DDDB-D64B-827C-2021B2D1B4AC}"/>
              </a:ext>
            </a:extLst>
          </p:cNvPr>
          <p:cNvSpPr txBox="1"/>
          <p:nvPr/>
        </p:nvSpPr>
        <p:spPr>
          <a:xfrm>
            <a:off x="233128" y="5367668"/>
            <a:ext cx="9435805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600" b="1" dirty="0"/>
              <a:t>Figure S1. </a:t>
            </a:r>
            <a:r>
              <a:rPr lang="fr-FR" sz="1600" dirty="0"/>
              <a:t>Phylogenetic tree of pathotype-A* </a:t>
            </a:r>
            <a:r>
              <a:rPr lang="fr-FR" sz="1600" i="1" dirty="0"/>
              <a:t>X. citri</a:t>
            </a:r>
            <a:r>
              <a:rPr lang="fr-FR" sz="1600" dirty="0"/>
              <a:t> pv. </a:t>
            </a:r>
            <a:r>
              <a:rPr lang="fr-FR" sz="1600" i="1" dirty="0"/>
              <a:t>citri</a:t>
            </a:r>
            <a:r>
              <a:rPr lang="fr-FR" sz="1600" dirty="0"/>
              <a:t> strains. Genome-wide pairwise average nucleotide identities were calculated and their phylogenetic analysis was performed on the enve-omics platform [</a:t>
            </a:r>
            <a:r>
              <a:rPr lang="fr-FR" sz="1600" dirty="0">
                <a:solidFill>
                  <a:srgbClr val="0070C0"/>
                </a:solidFill>
              </a:rPr>
              <a:t>21</a:t>
            </a:r>
            <a:r>
              <a:rPr lang="fr-FR" sz="1600" dirty="0"/>
              <a:t>]. Strain names are shown to the left of the tree, followed by the spoligotype number and the geographic origin of the strain. Pathotype-A* strains are framed by a transparent yellow box. Transparent blue, green, red and purple boxes frame four genetic lineages within pathotype A*. </a:t>
            </a:r>
          </a:p>
        </p:txBody>
      </p:sp>
    </p:spTree>
    <p:extLst>
      <p:ext uri="{BB962C8B-B14F-4D97-AF65-F5344CB8AC3E}">
        <p14:creationId xmlns:p14="http://schemas.microsoft.com/office/powerpoint/2010/main" val="27915752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51</TotalTime>
  <Words>73</Words>
  <Application>Microsoft Office PowerPoint</Application>
  <PresentationFormat>A4 Paper (210x297 mm)</PresentationFormat>
  <Paragraphs>6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DPI</cp:lastModifiedBy>
  <cp:revision>35</cp:revision>
  <dcterms:created xsi:type="dcterms:W3CDTF">2022-06-23T13:25:20Z</dcterms:created>
  <dcterms:modified xsi:type="dcterms:W3CDTF">2022-08-26T08:38:05Z</dcterms:modified>
</cp:coreProperties>
</file>